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9" r:id="rId3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3" d="100"/>
          <a:sy n="103" d="100"/>
        </p:scale>
        <p:origin x="-276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de-AT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de-A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8E6060-5706-4B58-9B98-FF0720497600}" type="datetimeFigureOut">
              <a:rPr lang="de-AT" smtClean="0"/>
              <a:t>19.10.2016</a:t>
            </a:fld>
            <a:endParaRPr lang="de-A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31062C-CC40-4B4D-A485-0832CB12FEE1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16398764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AT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A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8E6060-5706-4B58-9B98-FF0720497600}" type="datetimeFigureOut">
              <a:rPr lang="de-AT" smtClean="0"/>
              <a:t>19.10.2016</a:t>
            </a:fld>
            <a:endParaRPr lang="de-A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31062C-CC40-4B4D-A485-0832CB12FEE1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9619614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de-AT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A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8E6060-5706-4B58-9B98-FF0720497600}" type="datetimeFigureOut">
              <a:rPr lang="de-AT" smtClean="0"/>
              <a:t>19.10.2016</a:t>
            </a:fld>
            <a:endParaRPr lang="de-A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31062C-CC40-4B4D-A485-0832CB12FEE1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27533217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AT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A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8E6060-5706-4B58-9B98-FF0720497600}" type="datetimeFigureOut">
              <a:rPr lang="de-AT" smtClean="0"/>
              <a:t>19.10.2016</a:t>
            </a:fld>
            <a:endParaRPr lang="de-A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31062C-CC40-4B4D-A485-0832CB12FEE1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8796719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de-A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8E6060-5706-4B58-9B98-FF0720497600}" type="datetimeFigureOut">
              <a:rPr lang="de-AT" smtClean="0"/>
              <a:t>19.10.2016</a:t>
            </a:fld>
            <a:endParaRPr lang="de-A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31062C-CC40-4B4D-A485-0832CB12FEE1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3888247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AT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AT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AT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8E6060-5706-4B58-9B98-FF0720497600}" type="datetimeFigureOut">
              <a:rPr lang="de-AT" smtClean="0"/>
              <a:t>19.10.2016</a:t>
            </a:fld>
            <a:endParaRPr lang="de-A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31062C-CC40-4B4D-A485-0832CB12FEE1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35129667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de-A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AT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AT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8E6060-5706-4B58-9B98-FF0720497600}" type="datetimeFigureOut">
              <a:rPr lang="de-AT" smtClean="0"/>
              <a:t>19.10.2016</a:t>
            </a:fld>
            <a:endParaRPr lang="de-A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31062C-CC40-4B4D-A485-0832CB12FEE1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38459685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AT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8E6060-5706-4B58-9B98-FF0720497600}" type="datetimeFigureOut">
              <a:rPr lang="de-AT" smtClean="0"/>
              <a:t>19.10.2016</a:t>
            </a:fld>
            <a:endParaRPr lang="de-A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31062C-CC40-4B4D-A485-0832CB12FEE1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20178458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8E6060-5706-4B58-9B98-FF0720497600}" type="datetimeFigureOut">
              <a:rPr lang="de-AT" smtClean="0"/>
              <a:t>19.10.2016</a:t>
            </a:fld>
            <a:endParaRPr lang="de-A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31062C-CC40-4B4D-A485-0832CB12FEE1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24546157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de-AT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AT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8E6060-5706-4B58-9B98-FF0720497600}" type="datetimeFigureOut">
              <a:rPr lang="de-AT" smtClean="0"/>
              <a:t>19.10.2016</a:t>
            </a:fld>
            <a:endParaRPr lang="de-A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31062C-CC40-4B4D-A485-0832CB12FEE1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20062668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de-AT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AT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8E6060-5706-4B58-9B98-FF0720497600}" type="datetimeFigureOut">
              <a:rPr lang="de-AT" smtClean="0"/>
              <a:t>19.10.2016</a:t>
            </a:fld>
            <a:endParaRPr lang="de-A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31062C-CC40-4B4D-A485-0832CB12FEE1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7337556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de-A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A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8E6060-5706-4B58-9B98-FF0720497600}" type="datetimeFigureOut">
              <a:rPr lang="de-AT" smtClean="0"/>
              <a:t>19.10.2016</a:t>
            </a:fld>
            <a:endParaRPr lang="de-A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A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31062C-CC40-4B4D-A485-0832CB12FEE1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6457622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5" Type="http://schemas.openxmlformats.org/officeDocument/2006/relationships/image" Target="../media/image4.pn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7" Type="http://schemas.openxmlformats.org/officeDocument/2006/relationships/image" Target="../media/image10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Relationship Id="rId6" Type="http://schemas.microsoft.com/office/2007/relationships/hdphoto" Target="../media/hdphoto2.wdp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0" y="2168713"/>
            <a:ext cx="9221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ormoxia</a:t>
            </a:r>
            <a:endParaRPr lang="de-AT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1763688" y="980437"/>
            <a:ext cx="10081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untreated</a:t>
            </a:r>
            <a:endParaRPr lang="de-AT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3990780" y="971364"/>
            <a:ext cx="20162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sz="12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afilomycin A, 1 nM</a:t>
            </a:r>
            <a:endParaRPr lang="de-AT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Rectangle 9"/>
          <p:cNvSpPr/>
          <p:nvPr/>
        </p:nvSpPr>
        <p:spPr>
          <a:xfrm>
            <a:off x="6966405" y="971363"/>
            <a:ext cx="153394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AT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afilomycin A, 5 nM</a:t>
            </a:r>
            <a:endParaRPr lang="de-AT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13896" y="4459982"/>
            <a:ext cx="9306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tarvation</a:t>
            </a:r>
            <a:endParaRPr lang="de-AT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32" name="Picture 8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33656" y="1248364"/>
            <a:ext cx="2679145" cy="21086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3" name="Picture 9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444208" y="1257436"/>
            <a:ext cx="2624444" cy="20995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4" name="Picture 10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30645" y="1248363"/>
            <a:ext cx="2631666" cy="21086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0" y="0"/>
            <a:ext cx="90686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/>
            <a:r>
              <a:rPr lang="de-AT" sz="14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dditional file 6: </a:t>
            </a:r>
            <a:r>
              <a:rPr lang="de-AT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de-AT" sz="14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6A</a:t>
            </a:r>
            <a:r>
              <a:rPr lang="de-AT" sz="14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Bafilomycin A1 treatment of MSCs</a:t>
            </a:r>
            <a:r>
              <a:rPr lang="de-AT" sz="12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de-AT" sz="12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5" name="Picture 6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33656" y="3544885"/>
            <a:ext cx="2679145" cy="210719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6" name="Picture 7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444208" y="3544885"/>
            <a:ext cx="2624444" cy="210719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44541" y="3544885"/>
            <a:ext cx="2617770" cy="210719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107504" y="5805264"/>
            <a:ext cx="896114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Legend. </a:t>
            </a:r>
            <a:r>
              <a:rPr lang="de-AT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hTERT-positive MSCs were starved for 3 days and treated with bafilomycin A1 for the last 3 hs. Pictures are representative of 3 independent experiments.</a:t>
            </a:r>
            <a:endParaRPr lang="de-AT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3956983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" name="Group 18"/>
          <p:cNvGrpSpPr/>
          <p:nvPr/>
        </p:nvGrpSpPr>
        <p:grpSpPr>
          <a:xfrm>
            <a:off x="2115723" y="1459897"/>
            <a:ext cx="4544509" cy="1940179"/>
            <a:chOff x="2115723" y="1459897"/>
            <a:chExt cx="4544509" cy="1940179"/>
          </a:xfrm>
        </p:grpSpPr>
        <p:pic>
          <p:nvPicPr>
            <p:cNvPr id="1026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4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flipH="1">
              <a:off x="2937156" y="2172050"/>
              <a:ext cx="3363036" cy="3386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5" name="TextBox 4"/>
            <p:cNvSpPr txBox="1"/>
            <p:nvPr/>
          </p:nvSpPr>
          <p:spPr>
            <a:xfrm>
              <a:off x="2175322" y="2233739"/>
              <a:ext cx="61206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53</a:t>
              </a:r>
              <a:endParaRPr lang="de-AT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2787390" y="1459897"/>
              <a:ext cx="387284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control   1nM      5nM       starv    st, 1nM   st, 5nM</a:t>
              </a:r>
              <a:endParaRPr lang="de-AT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2" name="Picture 3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flipH="1">
              <a:off x="2932428" y="1778256"/>
              <a:ext cx="3367764" cy="3059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3" name="TextBox 12"/>
            <p:cNvSpPr txBox="1"/>
            <p:nvPr/>
          </p:nvSpPr>
          <p:spPr>
            <a:xfrm>
              <a:off x="2156798" y="1817154"/>
              <a:ext cx="74673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ECN1</a:t>
              </a:r>
              <a:endParaRPr lang="de-AT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7" name="Picture 2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flipH="1">
              <a:off x="2932428" y="3068960"/>
              <a:ext cx="3367764" cy="3227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8" name="TextBox 17"/>
            <p:cNvSpPr txBox="1"/>
            <p:nvPr/>
          </p:nvSpPr>
          <p:spPr>
            <a:xfrm>
              <a:off x="2115723" y="3123077"/>
              <a:ext cx="82143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  <a:endParaRPr lang="de-AT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2193846" y="2605296"/>
              <a:ext cx="70969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C3-I</a:t>
              </a:r>
            </a:p>
            <a:p>
              <a:r>
                <a:rPr lang="de-AT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C3-II</a:t>
              </a:r>
              <a:endParaRPr lang="de-AT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3" name="Picture 10"/>
            <p:cNvPicPr>
              <a:picLocks noChangeAspect="1"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flipH="1">
              <a:off x="2939458" y="2636912"/>
              <a:ext cx="3360734" cy="3086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sp>
        <p:nvSpPr>
          <p:cNvPr id="16" name="TextBox 15"/>
          <p:cNvSpPr txBox="1"/>
          <p:nvPr/>
        </p:nvSpPr>
        <p:spPr>
          <a:xfrm>
            <a:off x="0" y="0"/>
            <a:ext cx="716428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Additional file 6: </a:t>
            </a:r>
            <a:r>
              <a:rPr lang="de-AT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de-AT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S6B</a:t>
            </a:r>
            <a:r>
              <a:rPr lang="de-AT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. WB analysis of MSCs treated with bafilomycin A1. </a:t>
            </a:r>
            <a:endParaRPr lang="de-AT" sz="1400" dirty="0"/>
          </a:p>
        </p:txBody>
      </p:sp>
      <p:sp>
        <p:nvSpPr>
          <p:cNvPr id="20" name="TextBox 19"/>
          <p:cNvSpPr txBox="1"/>
          <p:nvPr/>
        </p:nvSpPr>
        <p:spPr>
          <a:xfrm>
            <a:off x="2339752" y="3789040"/>
            <a:ext cx="410634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Legend. </a:t>
            </a:r>
            <a:r>
              <a:rPr lang="de-AT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MSCs treated with bafilomycin A1 were subjected to WB to detect autophagy-involved proteins.</a:t>
            </a:r>
            <a:endParaRPr lang="de-AT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200086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4</Words>
  <Application>Microsoft Office PowerPoint</Application>
  <PresentationFormat>On-screen Show (4:3)</PresentationFormat>
  <Paragraphs>15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usak Zvenyslava</dc:creator>
  <cp:lastModifiedBy>Husak Zvenyslava</cp:lastModifiedBy>
  <cp:revision>20</cp:revision>
  <dcterms:created xsi:type="dcterms:W3CDTF">2016-09-20T12:22:40Z</dcterms:created>
  <dcterms:modified xsi:type="dcterms:W3CDTF">2016-10-19T12:04:31Z</dcterms:modified>
</cp:coreProperties>
</file>